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1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150" y="31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221BE-48E3-4CE5-BAE7-83CBFCFE3AA5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3A395-FB9F-44CC-B321-43E8AD90D0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4639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221BE-48E3-4CE5-BAE7-83CBFCFE3AA5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3A395-FB9F-44CC-B321-43E8AD90D0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6289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221BE-48E3-4CE5-BAE7-83CBFCFE3AA5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3A395-FB9F-44CC-B321-43E8AD90D0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1336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221BE-48E3-4CE5-BAE7-83CBFCFE3AA5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3A395-FB9F-44CC-B321-43E8AD90D0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0016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221BE-48E3-4CE5-BAE7-83CBFCFE3AA5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3A395-FB9F-44CC-B321-43E8AD90D0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5535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221BE-48E3-4CE5-BAE7-83CBFCFE3AA5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3A395-FB9F-44CC-B321-43E8AD90D0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376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221BE-48E3-4CE5-BAE7-83CBFCFE3AA5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3A395-FB9F-44CC-B321-43E8AD90D0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7708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221BE-48E3-4CE5-BAE7-83CBFCFE3AA5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3A395-FB9F-44CC-B321-43E8AD90D0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6266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221BE-48E3-4CE5-BAE7-83CBFCFE3AA5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3A395-FB9F-44CC-B321-43E8AD90D0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1218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221BE-48E3-4CE5-BAE7-83CBFCFE3AA5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3A395-FB9F-44CC-B321-43E8AD90D0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1568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221BE-48E3-4CE5-BAE7-83CBFCFE3AA5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3A395-FB9F-44CC-B321-43E8AD90D0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7729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D221BE-48E3-4CE5-BAE7-83CBFCFE3AA5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73A395-FB9F-44CC-B321-43E8AD90D0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3982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/>
        </p:nvGraphicFramePr>
        <p:xfrm>
          <a:off x="3719513" y="2133600"/>
          <a:ext cx="3937000" cy="1085850"/>
        </p:xfrm>
        <a:graphic>
          <a:graphicData uri="http://schemas.openxmlformats.org/drawingml/2006/table">
            <a:tbl>
              <a:tblPr/>
              <a:tblGrid>
                <a:gridCol w="2289604"/>
                <a:gridCol w="725971"/>
                <a:gridCol w="921425"/>
              </a:tblGrid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 facto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4P (n=11)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(n=11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in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ars (mean ± SD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1 ± 10.4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3 ± 5.9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BeAg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positiv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</a:t>
                      </a:r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7%)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</a:t>
                      </a:r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5%)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 (IU/L)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ean ± SD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9 ± 39.5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5 ± 68.3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BV-DNA (pg/ml) median (range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4357" name="직사각형 2"/>
          <p:cNvSpPr>
            <a:spLocks noChangeArrowheads="1"/>
          </p:cNvSpPr>
          <p:nvPr/>
        </p:nvSpPr>
        <p:spPr bwMode="auto">
          <a:xfrm>
            <a:off x="3609975" y="1773239"/>
            <a:ext cx="28956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40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Table S1. Clinical factors of patients. </a:t>
            </a:r>
            <a:endParaRPr lang="ko-KR" altLang="en-US" sz="140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14358" name="TextBox 11"/>
          <p:cNvSpPr txBox="1">
            <a:spLocks noChangeArrowheads="1"/>
          </p:cNvSpPr>
          <p:nvPr/>
        </p:nvSpPr>
        <p:spPr bwMode="auto">
          <a:xfrm>
            <a:off x="1595439" y="239714"/>
            <a:ext cx="356393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Additional file 5: Table S1. </a:t>
            </a:r>
            <a:endParaRPr lang="ko-KR" altLang="en-US" sz="16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7635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</Words>
  <Application>Microsoft Office PowerPoint</Application>
  <PresentationFormat>와이드스크린</PresentationFormat>
  <Paragraphs>1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굴림</vt:lpstr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cro</dc:creator>
  <cp:lastModifiedBy>Micro</cp:lastModifiedBy>
  <cp:revision>1</cp:revision>
  <dcterms:created xsi:type="dcterms:W3CDTF">2015-01-08T08:32:43Z</dcterms:created>
  <dcterms:modified xsi:type="dcterms:W3CDTF">2015-01-08T08:33:04Z</dcterms:modified>
</cp:coreProperties>
</file>